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DAE33-9FE1-C645-9247-64529464FD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35D593-7D7D-5F4D-BB1F-45E4FB0A9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43CD0-83CC-E049-9C16-B5DC163EE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BB364C-A3DA-C645-B2DC-4E1684AB6F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4F644-02FD-FF46-B1D5-D2F73ADF3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232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827070-BB07-1541-9145-67EC81954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44537F-E023-D94B-8182-30889361E4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215E97-3D0C-8246-8D96-74DFB2BF9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DBEE85-4A56-3A40-8B7C-83319740D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C6DAE-63D9-7342-B810-098069C7C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265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F0A8B7-2890-0F43-9153-0002396C77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7F50F0-E265-4A40-B4D2-ECB580C710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A73EE3-BF14-1045-9E59-CD65D7AC7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FC637-02AF-1A4A-876E-879E9C5B5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563594-8CAB-7C4B-BD1C-7DE28DD2A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577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879D6-2838-FD4C-AC5C-57B41F56B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2791B5-40A8-854D-B50C-E5CE387664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A1B4A4-3A59-5F43-A9E1-CEC9803C2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175ACC-9824-A24C-941F-0E12EA9E5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BDA67-37CB-664A-867F-AAAA4DFD2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431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CE6FC-E498-A04B-913D-D4AA712AC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822BEE-AD75-574F-AA97-A793065AF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40FBFC-9F3F-F749-8BAE-8B513F2D6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0FC8B3-A9E4-774B-98B7-5C8719453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85186-02D5-FF43-B600-A1797D3FC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020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2376D-738A-9443-A952-E31450BE8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600443-9324-3A46-8B3A-E6531447FF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E5BA78-9031-6B44-81A8-9356DDD0D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7F84BE-B384-354F-9C18-894A8C6AF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51F9C5-2C64-C348-A0C3-0D0D799DA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F45909-B426-8C47-8FF0-BC8D64915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33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B175A-0AE3-1842-89CF-0E547D27CA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440C2D-262D-D64C-ADF9-A95F84CF04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BE0298-0E09-C94E-9BFC-A690CA2B0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557818-88E9-DF4A-877C-316684459E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1BA9F3-5B29-7D4F-AFC1-BF61787E1B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27A1545-DDEF-FE4B-8F8C-87B26D225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214DB9-EB91-9848-B3F1-7B2281F54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67963E-0C92-9C43-8C53-BA75CB680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147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362B9-9C95-D14A-AF27-620AF9A1A3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061CC6-C094-A041-8201-59230DB40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DB152A-515F-0349-9F50-C853530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81ABC1-5AF8-8549-B1C0-9CBFA7FEA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416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8D875E-D6B6-2D48-8A52-2AD550886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E8F987-467A-F948-90B7-6CC43E980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804D09-D716-CA40-A13F-1A2BCF7EA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84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5B6C2-1EB8-3644-9965-4A0640D16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E3B13-99DF-5C4C-B71B-65BB0AB979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F77D2E-CD83-594E-BB47-EB904C072A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E9CF1D-9071-954B-8F16-622A8EC0B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19EFDD-B4F8-524C-A205-7FA73E13A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530B6E-5B6E-1C41-A879-902259942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75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6E3E8-EE15-FC48-BBAA-078890903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4AD4A5-12B4-1C41-A059-98BBF5D6FA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E4CE33-E996-C84C-9338-2694E225A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C6C9-4F85-1B45-8153-4CC58D559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F9315C-C198-E542-B8C6-B31A33220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75E336-5EBE-844C-953F-B8EEE6130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035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E9584C-DEC0-0F40-A902-6221D9AA1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FB07E0-6007-2145-B2DC-A182520BF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349DD1-14C4-A645-A448-D759EF49FE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941BFE-1E65-2947-ACEF-5B7F13F4C369}" type="datetimeFigureOut">
              <a:rPr lang="en-US" smtClean="0"/>
              <a:t>9/1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51FB7-1751-9C47-94AB-969521D2A0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178E37-97BF-5D48-8699-C2403BB234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F1EBC-AB2B-1244-A732-BB03110F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033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280" y="2440447"/>
            <a:ext cx="2589645" cy="406499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677" t="6418" r="3733" b="6161"/>
          <a:stretch/>
        </p:blipFill>
        <p:spPr>
          <a:xfrm>
            <a:off x="4111453" y="2550438"/>
            <a:ext cx="2589645" cy="384501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4" t="6846" r="1120" b="5865"/>
          <a:stretch/>
        </p:blipFill>
        <p:spPr>
          <a:xfrm>
            <a:off x="6830490" y="2500095"/>
            <a:ext cx="2728917" cy="385246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295280" y="2177114"/>
            <a:ext cx="2407308" cy="307777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GB" sz="1400" dirty="0"/>
              <a:t> CAL04        Mock    -Titratio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3353" y="2793341"/>
            <a:ext cx="531927" cy="2092881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pPr algn="r"/>
            <a:r>
              <a:rPr lang="en-GB" sz="1000" dirty="0"/>
              <a:t>1/2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 1/4 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1/8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1/16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1/32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 1/64</a:t>
            </a:r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 1/12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88D575-EAD2-AD43-B6BB-BD3D34A481CC}"/>
              </a:ext>
            </a:extLst>
          </p:cNvPr>
          <p:cNvSpPr txBox="1"/>
          <p:nvPr/>
        </p:nvSpPr>
        <p:spPr>
          <a:xfrm rot="17370530">
            <a:off x="3406768" y="1199417"/>
            <a:ext cx="2537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C309L/N297A/C575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28BDEC-9AAB-E148-A931-01F8561D3569}"/>
              </a:ext>
            </a:extLst>
          </p:cNvPr>
          <p:cNvSpPr txBox="1"/>
          <p:nvPr/>
        </p:nvSpPr>
        <p:spPr>
          <a:xfrm rot="17370530">
            <a:off x="3722106" y="1232549"/>
            <a:ext cx="2537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C309L/N563A/C575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5C5AF57-C3DA-5F45-B9B8-E2691D1895D2}"/>
              </a:ext>
            </a:extLst>
          </p:cNvPr>
          <p:cNvSpPr txBox="1"/>
          <p:nvPr/>
        </p:nvSpPr>
        <p:spPr>
          <a:xfrm rot="17370530">
            <a:off x="4364151" y="1623947"/>
            <a:ext cx="1672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C575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7A1A8B-47E7-044F-9030-3D9F019D5B33}"/>
              </a:ext>
            </a:extLst>
          </p:cNvPr>
          <p:cNvSpPr txBox="1"/>
          <p:nvPr/>
        </p:nvSpPr>
        <p:spPr>
          <a:xfrm rot="17370530">
            <a:off x="4848014" y="1845645"/>
            <a:ext cx="1184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IgG1-F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EBDE941-4D5D-C14A-B092-A3B617FEC9A3}"/>
              </a:ext>
            </a:extLst>
          </p:cNvPr>
          <p:cNvSpPr txBox="1"/>
          <p:nvPr/>
        </p:nvSpPr>
        <p:spPr>
          <a:xfrm rot="17370530">
            <a:off x="4747375" y="1287747"/>
            <a:ext cx="2390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C309L/N297A/NA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9E61ABB-5340-D248-8492-DF37FDCDDF7C}"/>
              </a:ext>
            </a:extLst>
          </p:cNvPr>
          <p:cNvSpPr txBox="1"/>
          <p:nvPr/>
        </p:nvSpPr>
        <p:spPr>
          <a:xfrm rot="17370530">
            <a:off x="5075377" y="1294901"/>
            <a:ext cx="2390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C309L/N563A/NA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9D59DC2-FA0E-CE4E-884D-807D7A366170}"/>
              </a:ext>
            </a:extLst>
          </p:cNvPr>
          <p:cNvSpPr txBox="1"/>
          <p:nvPr/>
        </p:nvSpPr>
        <p:spPr>
          <a:xfrm rot="17370530">
            <a:off x="5692286" y="1737971"/>
            <a:ext cx="1465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K1-D221N/NA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0B93E88-FB8F-7C4B-BFD6-D139BB1DD582}"/>
              </a:ext>
            </a:extLst>
          </p:cNvPr>
          <p:cNvSpPr txBox="1"/>
          <p:nvPr/>
        </p:nvSpPr>
        <p:spPr>
          <a:xfrm rot="17370530">
            <a:off x="5745994" y="1351972"/>
            <a:ext cx="230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EK-D221N/C309L/N297A/C575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8809E39-DB9B-0A40-95A5-6FCEBB43CD21}"/>
              </a:ext>
            </a:extLst>
          </p:cNvPr>
          <p:cNvSpPr txBox="1"/>
          <p:nvPr/>
        </p:nvSpPr>
        <p:spPr>
          <a:xfrm rot="17370530">
            <a:off x="6201165" y="1332355"/>
            <a:ext cx="230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EK-D221N/C309L/N563A/C575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686E20D-29A9-B34F-96F0-E64D6A3E6349}"/>
              </a:ext>
            </a:extLst>
          </p:cNvPr>
          <p:cNvSpPr txBox="1"/>
          <p:nvPr/>
        </p:nvSpPr>
        <p:spPr>
          <a:xfrm rot="17370530">
            <a:off x="6986719" y="1979145"/>
            <a:ext cx="947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EK-IgG1-F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010764-7E73-7244-9D3F-AB9D6591B6D1}"/>
              </a:ext>
            </a:extLst>
          </p:cNvPr>
          <p:cNvSpPr txBox="1"/>
          <p:nvPr/>
        </p:nvSpPr>
        <p:spPr>
          <a:xfrm rot="17370530">
            <a:off x="6891273" y="1406481"/>
            <a:ext cx="2153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EK-D221N/C309L/N297A/NA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D6C84C-6E2F-1A4B-A50B-0BEB415B275C}"/>
              </a:ext>
            </a:extLst>
          </p:cNvPr>
          <p:cNvSpPr txBox="1"/>
          <p:nvPr/>
        </p:nvSpPr>
        <p:spPr>
          <a:xfrm rot="17370530">
            <a:off x="7503553" y="1834394"/>
            <a:ext cx="12288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EK-D221N/NA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CAA8E11-B117-9A4C-B152-16CAA6B758A0}"/>
              </a:ext>
            </a:extLst>
          </p:cNvPr>
          <p:cNvSpPr txBox="1"/>
          <p:nvPr/>
        </p:nvSpPr>
        <p:spPr>
          <a:xfrm rot="17370530">
            <a:off x="7449578" y="1199418"/>
            <a:ext cx="24490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S-D221N/C309L/N297A/C575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4B8FAA-89D1-B842-B47B-F2DF0A1E7F81}"/>
              </a:ext>
            </a:extLst>
          </p:cNvPr>
          <p:cNvSpPr txBox="1"/>
          <p:nvPr/>
        </p:nvSpPr>
        <p:spPr>
          <a:xfrm rot="17370530">
            <a:off x="7768695" y="1211483"/>
            <a:ext cx="24490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S-D221N/C309L/N563A/C575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6D1EE68-4719-1C4B-97DA-7F1A489DEDEC}"/>
              </a:ext>
            </a:extLst>
          </p:cNvPr>
          <p:cNvSpPr txBox="1"/>
          <p:nvPr/>
        </p:nvSpPr>
        <p:spPr>
          <a:xfrm rot="17370530">
            <a:off x="8381380" y="1649313"/>
            <a:ext cx="1524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S-D221N/C575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4BC5988-FA5F-E343-8828-B87C7443F0CC}"/>
              </a:ext>
            </a:extLst>
          </p:cNvPr>
          <p:cNvSpPr txBox="1"/>
          <p:nvPr/>
        </p:nvSpPr>
        <p:spPr>
          <a:xfrm rot="17370530">
            <a:off x="8864327" y="1796364"/>
            <a:ext cx="1095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HO-S-IgG1-Fc</a:t>
            </a:r>
          </a:p>
        </p:txBody>
      </p:sp>
    </p:spTree>
    <p:extLst>
      <p:ext uri="{BB962C8B-B14F-4D97-AF65-F5344CB8AC3E}">
        <p14:creationId xmlns:p14="http://schemas.microsoft.com/office/powerpoint/2010/main" val="3139822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93</Words>
  <Application>Microsoft Macintosh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Pleass</dc:creator>
  <cp:lastModifiedBy>Richard Pleass</cp:lastModifiedBy>
  <cp:revision>3</cp:revision>
  <cp:lastPrinted>2022-09-16T09:28:30Z</cp:lastPrinted>
  <dcterms:created xsi:type="dcterms:W3CDTF">2022-09-15T12:56:55Z</dcterms:created>
  <dcterms:modified xsi:type="dcterms:W3CDTF">2022-09-16T09:42:34Z</dcterms:modified>
</cp:coreProperties>
</file>